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8" d="100"/>
          <a:sy n="88" d="100"/>
        </p:scale>
        <p:origin x="-1392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77CA5-B9FF-5A49-A0A7-9A2E733060AB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E351C-DE0B-9545-BE26-33AD3593CD3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9860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77CA5-B9FF-5A49-A0A7-9A2E733060AB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E351C-DE0B-9545-BE26-33AD3593CD3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9079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77CA5-B9FF-5A49-A0A7-9A2E733060AB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E351C-DE0B-9545-BE26-33AD3593CD3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85361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77CA5-B9FF-5A49-A0A7-9A2E733060AB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E351C-DE0B-9545-BE26-33AD3593CD3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8911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77CA5-B9FF-5A49-A0A7-9A2E733060AB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E351C-DE0B-9545-BE26-33AD3593CD3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7510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77CA5-B9FF-5A49-A0A7-9A2E733060AB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E351C-DE0B-9545-BE26-33AD3593CD3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08955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77CA5-B9FF-5A49-A0A7-9A2E733060AB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E351C-DE0B-9545-BE26-33AD3593CD3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5185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77CA5-B9FF-5A49-A0A7-9A2E733060AB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E351C-DE0B-9545-BE26-33AD3593CD3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3941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77CA5-B9FF-5A49-A0A7-9A2E733060AB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E351C-DE0B-9545-BE26-33AD3593CD3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9065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77CA5-B9FF-5A49-A0A7-9A2E733060AB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E351C-DE0B-9545-BE26-33AD3593CD3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5050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77CA5-B9FF-5A49-A0A7-9A2E733060AB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E351C-DE0B-9545-BE26-33AD3593CD3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4574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377CA5-B9FF-5A49-A0A7-9A2E733060AB}" type="datetimeFigureOut">
              <a:rPr lang="es-ES" smtClean="0"/>
              <a:t>30/10/18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E351C-DE0B-9545-BE26-33AD3593CD30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9623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Macintosh HD:Users:Ruddy:Desktop:Figuras paper Vit D:Vitamin D levels.jp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8094" y="505094"/>
            <a:ext cx="5238199" cy="6519379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CuadroTexto 5"/>
          <p:cNvSpPr txBox="1"/>
          <p:nvPr/>
        </p:nvSpPr>
        <p:spPr>
          <a:xfrm>
            <a:off x="533922" y="7273349"/>
            <a:ext cx="600980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dirty="0"/>
              <a:t>Supplementary Figure 1: </a:t>
            </a:r>
            <a:r>
              <a:rPr lang="en-GB" sz="1400" b="1" dirty="0"/>
              <a:t>Distribution of vitamin D levels across the seasons of the year in the studied population. </a:t>
            </a:r>
            <a:r>
              <a:rPr lang="en-GB" sz="1400" dirty="0"/>
              <a:t>In all the seasons the differences are highly significant between the studied groups (normal levels </a:t>
            </a:r>
            <a:r>
              <a:rPr lang="en-GB" sz="1400" dirty="0" err="1"/>
              <a:t>vs</a:t>
            </a:r>
            <a:r>
              <a:rPr lang="en-GB" sz="1400" dirty="0"/>
              <a:t> insufficiency). Data have been analysed with a non-parametric test (Mann-Whitney test). *** p&lt;0.0001</a:t>
            </a:r>
            <a:endParaRPr lang="es-ES" sz="1400" dirty="0"/>
          </a:p>
          <a:p>
            <a:pPr algn="just"/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147401638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3</Words>
  <Application>Microsoft Macintosh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NEIRID LAB  XXI SANTIAG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Oreste Gualillo</dc:creator>
  <cp:lastModifiedBy>Oreste Gualillo</cp:lastModifiedBy>
  <cp:revision>2</cp:revision>
  <dcterms:created xsi:type="dcterms:W3CDTF">2018-10-25T07:32:50Z</dcterms:created>
  <dcterms:modified xsi:type="dcterms:W3CDTF">2018-10-30T10:01:24Z</dcterms:modified>
</cp:coreProperties>
</file>